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34" y="-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94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961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4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305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862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311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024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223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12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505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278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8B697B-E1CB-4B82-A193-629DDF411DE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354FD-4BD2-4C35-8861-831C78439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718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2377" y="2108284"/>
            <a:ext cx="1434291" cy="13243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2317" y="2108283"/>
            <a:ext cx="1434293" cy="13278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8" t="2412" r="4106" b="3269"/>
          <a:stretch/>
        </p:blipFill>
        <p:spPr bwMode="auto">
          <a:xfrm>
            <a:off x="2570003" y="2108283"/>
            <a:ext cx="1434295" cy="13278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4"/>
          <a:stretch/>
        </p:blipFill>
        <p:spPr bwMode="auto">
          <a:xfrm>
            <a:off x="1112318" y="750352"/>
            <a:ext cx="1434291" cy="132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304"/>
          <a:stretch/>
        </p:blipFill>
        <p:spPr bwMode="auto">
          <a:xfrm>
            <a:off x="2570005" y="750352"/>
            <a:ext cx="1434291" cy="132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3350" y="750352"/>
            <a:ext cx="1434291" cy="132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65"/>
          <a:stretch/>
        </p:blipFill>
        <p:spPr bwMode="auto">
          <a:xfrm>
            <a:off x="5472377" y="750352"/>
            <a:ext cx="1434291" cy="132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2377" y="3466818"/>
            <a:ext cx="1434291" cy="132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0005" y="3466818"/>
            <a:ext cx="1434291" cy="132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2318" y="3466818"/>
            <a:ext cx="1434291" cy="132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3350" y="3466818"/>
            <a:ext cx="1434291" cy="132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3348" y="2108284"/>
            <a:ext cx="1434294" cy="13243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5718" y="3466818"/>
            <a:ext cx="1433830" cy="1320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0" name="TextBox 69"/>
          <p:cNvSpPr txBox="1"/>
          <p:nvPr/>
        </p:nvSpPr>
        <p:spPr>
          <a:xfrm>
            <a:off x="6881268" y="2490960"/>
            <a:ext cx="1500732" cy="579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US" sz="1500" b="1" dirty="0" smtClean="0">
                <a:solidFill>
                  <a:srgbClr val="0CE426"/>
                </a:solidFill>
                <a:latin typeface="Arial" pitchFamily="34" charset="0"/>
                <a:cs typeface="Arial" pitchFamily="34" charset="0"/>
              </a:rPr>
              <a:t>SYCP3</a:t>
            </a:r>
            <a:r>
              <a:rPr lang="en-US" sz="15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5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YCP1</a:t>
            </a:r>
          </a:p>
          <a:p>
            <a:pPr algn="ctr">
              <a:lnSpc>
                <a:spcPts val="1900"/>
              </a:lnSpc>
            </a:pPr>
            <a:r>
              <a:rPr lang="en-US" sz="15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500" b="1" dirty="0" smtClean="0">
                <a:solidFill>
                  <a:schemeClr val="accent4"/>
                </a:solidFill>
                <a:latin typeface="Arial" pitchFamily="34" charset="0"/>
                <a:cs typeface="Arial" pitchFamily="34" charset="0"/>
              </a:rPr>
              <a:t>CREST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402102" y="472825"/>
            <a:ext cx="854721" cy="335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SYCP3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4313134" y="472825"/>
            <a:ext cx="854721" cy="335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SYCP1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2853123" y="472825"/>
            <a:ext cx="877163" cy="335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US" sz="1600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CREST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5777041" y="458536"/>
            <a:ext cx="788999" cy="335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Merge</a:t>
            </a:r>
          </a:p>
        </p:txBody>
      </p:sp>
      <p:sp>
        <p:nvSpPr>
          <p:cNvPr id="91" name="TextBox 90"/>
          <p:cNvSpPr txBox="1"/>
          <p:nvPr/>
        </p:nvSpPr>
        <p:spPr>
          <a:xfrm rot="16200000">
            <a:off x="372125" y="1174669"/>
            <a:ext cx="1096775" cy="453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Early </a:t>
            </a:r>
          </a:p>
          <a:p>
            <a:pPr algn="ctr">
              <a:lnSpc>
                <a:spcPts val="14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leptotene</a:t>
            </a:r>
          </a:p>
        </p:txBody>
      </p:sp>
      <p:sp>
        <p:nvSpPr>
          <p:cNvPr id="92" name="TextBox 91"/>
          <p:cNvSpPr txBox="1"/>
          <p:nvPr/>
        </p:nvSpPr>
        <p:spPr>
          <a:xfrm rot="16200000">
            <a:off x="372126" y="2530187"/>
            <a:ext cx="1096775" cy="453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Late </a:t>
            </a:r>
          </a:p>
          <a:p>
            <a:pPr algn="ctr">
              <a:lnSpc>
                <a:spcPts val="14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leptotene</a:t>
            </a:r>
          </a:p>
        </p:txBody>
      </p:sp>
      <p:sp>
        <p:nvSpPr>
          <p:cNvPr id="93" name="TextBox 92"/>
          <p:cNvSpPr txBox="1"/>
          <p:nvPr/>
        </p:nvSpPr>
        <p:spPr>
          <a:xfrm rot="16200000">
            <a:off x="373825" y="3901557"/>
            <a:ext cx="1095172" cy="45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Early </a:t>
            </a:r>
          </a:p>
          <a:p>
            <a:pPr algn="ctr">
              <a:lnSpc>
                <a:spcPts val="14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Zygotene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773464" y="437123"/>
            <a:ext cx="5029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2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1899556" y="4997008"/>
            <a:ext cx="548239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869413" y="5142131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No. of nuclei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896047" y="5493976"/>
            <a:ext cx="1194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Early leptotene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896047" y="5709556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Late leptoten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896047" y="6130529"/>
            <a:ext cx="10775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Mid zygotene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825835" y="5478587"/>
            <a:ext cx="6043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6.6±1.4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813638" y="5478587"/>
            <a:ext cx="1136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5.8±2.5 (97.8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162594" y="5694167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 smtClean="0">
                <a:latin typeface="Arial" pitchFamily="34" charset="0"/>
                <a:cs typeface="Arial" pitchFamily="34" charset="0"/>
              </a:rPr>
              <a:t>n.a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162594" y="5478587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 smtClean="0">
                <a:latin typeface="Arial" pitchFamily="34" charset="0"/>
                <a:cs typeface="Arial" pitchFamily="34" charset="0"/>
              </a:rPr>
              <a:t>n.a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175665" y="547858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70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175665" y="569416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60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896047" y="5926677"/>
            <a:ext cx="11801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Early zygotene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6162594" y="5911288"/>
            <a:ext cx="9412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0.3±0.9(1.0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175665" y="591128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60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896047" y="6343162"/>
            <a:ext cx="1243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Late zygotene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175665" y="612283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5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0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175665" y="632777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7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0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496247" y="5137666"/>
            <a:ext cx="12126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No. CREST foci      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509963" y="4953000"/>
            <a:ext cx="162182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No. co-localizing CREST/SYCP3 </a:t>
            </a:r>
          </a:p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oci  (%)                                 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909485" y="4953000"/>
            <a:ext cx="144779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No. co-localizing CREST/SYCP1 </a:t>
            </a:r>
          </a:p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oci  (%)                                 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3186270" y="529346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N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3825835" y="5694167"/>
            <a:ext cx="6043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7.3±1.3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813638" y="5694167"/>
            <a:ext cx="1136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36.7±1.8 (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98.4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762375" y="6327773"/>
            <a:ext cx="731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2.0±3.6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825835" y="6122834"/>
            <a:ext cx="6043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7.5±1.8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825834" y="5911288"/>
            <a:ext cx="6043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6.9±1.4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813638" y="6122834"/>
            <a:ext cx="1136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7.3±2.0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(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99.5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813638" y="5911288"/>
            <a:ext cx="1136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36.3±1.5 (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98.4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813638" y="6327773"/>
            <a:ext cx="1136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31.8±3.4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(99.4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896047" y="6538385"/>
            <a:ext cx="1243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Pachytene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3133185" y="652299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120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6162594" y="6122834"/>
            <a:ext cx="9412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0.4±0.9(1.2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6162594" y="6327773"/>
            <a:ext cx="1019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.8±2.3(11.9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762375" y="6522996"/>
            <a:ext cx="731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21.0±0.7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4813638" y="6522996"/>
            <a:ext cx="10983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21.0±0.8 (100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6162594" y="6522996"/>
            <a:ext cx="10983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19.1±0.4(91.0)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1554481" y="4948535"/>
            <a:ext cx="5029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itchFamily="34" charset="0"/>
                <a:cs typeface="Arial" pitchFamily="34" charset="0"/>
              </a:rPr>
              <a:t>B</a:t>
            </a:r>
            <a:endParaRPr lang="en-US" sz="2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4" name="Straight Arrow Connector 103"/>
          <p:cNvCxnSpPr/>
          <p:nvPr/>
        </p:nvCxnSpPr>
        <p:spPr>
          <a:xfrm>
            <a:off x="5891215" y="1479560"/>
            <a:ext cx="10152" cy="34914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5868018" y="685800"/>
            <a:ext cx="0" cy="58335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>
            <a:off x="6267452" y="1074797"/>
            <a:ext cx="0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/>
          <p:nvPr/>
        </p:nvCxnSpPr>
        <p:spPr>
          <a:xfrm flipH="1">
            <a:off x="6367459" y="1059408"/>
            <a:ext cx="23761" cy="36483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/>
          <p:cNvCxnSpPr/>
          <p:nvPr/>
        </p:nvCxnSpPr>
        <p:spPr>
          <a:xfrm flipH="1">
            <a:off x="6076948" y="1408175"/>
            <a:ext cx="67344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/>
          <p:cNvCxnSpPr/>
          <p:nvPr/>
        </p:nvCxnSpPr>
        <p:spPr>
          <a:xfrm flipH="1">
            <a:off x="6486526" y="1734125"/>
            <a:ext cx="76200" cy="418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/>
          <p:cNvCxnSpPr/>
          <p:nvPr/>
        </p:nvCxnSpPr>
        <p:spPr>
          <a:xfrm>
            <a:off x="2988833" y="1476384"/>
            <a:ext cx="12284" cy="31740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>
            <a:off x="3366818" y="1074797"/>
            <a:ext cx="0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 flipH="1">
            <a:off x="3466825" y="1060416"/>
            <a:ext cx="23761" cy="36483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/>
          <p:nvPr/>
        </p:nvCxnSpPr>
        <p:spPr>
          <a:xfrm flipH="1">
            <a:off x="3181505" y="1403412"/>
            <a:ext cx="67344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/>
          <p:cNvCxnSpPr/>
          <p:nvPr/>
        </p:nvCxnSpPr>
        <p:spPr>
          <a:xfrm flipH="1">
            <a:off x="3585892" y="1735133"/>
            <a:ext cx="76200" cy="418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/>
          <p:cNvCxnSpPr/>
          <p:nvPr/>
        </p:nvCxnSpPr>
        <p:spPr>
          <a:xfrm>
            <a:off x="1523095" y="1470034"/>
            <a:ext cx="10152" cy="34914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/>
          <p:cNvCxnSpPr/>
          <p:nvPr/>
        </p:nvCxnSpPr>
        <p:spPr>
          <a:xfrm>
            <a:off x="1895211" y="1071579"/>
            <a:ext cx="0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18"/>
          <p:cNvCxnSpPr/>
          <p:nvPr/>
        </p:nvCxnSpPr>
        <p:spPr>
          <a:xfrm>
            <a:off x="1647824" y="1325934"/>
            <a:ext cx="19050" cy="21851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/>
          <p:cNvCxnSpPr/>
          <p:nvPr/>
        </p:nvCxnSpPr>
        <p:spPr>
          <a:xfrm flipH="1">
            <a:off x="1990455" y="1046127"/>
            <a:ext cx="23761" cy="36483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/>
          <p:cNvCxnSpPr/>
          <p:nvPr/>
        </p:nvCxnSpPr>
        <p:spPr>
          <a:xfrm flipH="1">
            <a:off x="1719267" y="1400178"/>
            <a:ext cx="67344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/>
          <p:cNvCxnSpPr/>
          <p:nvPr/>
        </p:nvCxnSpPr>
        <p:spPr>
          <a:xfrm flipH="1">
            <a:off x="2119311" y="1719259"/>
            <a:ext cx="76200" cy="418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/>
          <p:cNvCxnSpPr/>
          <p:nvPr/>
        </p:nvCxnSpPr>
        <p:spPr>
          <a:xfrm>
            <a:off x="3109913" y="1323978"/>
            <a:ext cx="19050" cy="21851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/>
          <p:cNvCxnSpPr/>
          <p:nvPr/>
        </p:nvCxnSpPr>
        <p:spPr>
          <a:xfrm>
            <a:off x="6010276" y="1330697"/>
            <a:ext cx="19050" cy="21851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/>
          <p:cNvCxnSpPr/>
          <p:nvPr/>
        </p:nvCxnSpPr>
        <p:spPr>
          <a:xfrm flipH="1" flipV="1">
            <a:off x="1676400" y="3193733"/>
            <a:ext cx="90525" cy="14287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125"/>
          <p:cNvCxnSpPr/>
          <p:nvPr/>
        </p:nvCxnSpPr>
        <p:spPr>
          <a:xfrm>
            <a:off x="1463040" y="2393725"/>
            <a:ext cx="0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/>
          <p:cNvCxnSpPr/>
          <p:nvPr/>
        </p:nvCxnSpPr>
        <p:spPr>
          <a:xfrm flipH="1">
            <a:off x="2184081" y="2247900"/>
            <a:ext cx="23761" cy="36483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/>
          <p:cNvCxnSpPr/>
          <p:nvPr/>
        </p:nvCxnSpPr>
        <p:spPr>
          <a:xfrm flipH="1">
            <a:off x="1521817" y="2490960"/>
            <a:ext cx="67344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/>
          <p:cNvCxnSpPr/>
          <p:nvPr/>
        </p:nvCxnSpPr>
        <p:spPr>
          <a:xfrm flipH="1">
            <a:off x="1719937" y="2994660"/>
            <a:ext cx="76200" cy="418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Arrow Connector 129"/>
          <p:cNvCxnSpPr/>
          <p:nvPr/>
        </p:nvCxnSpPr>
        <p:spPr>
          <a:xfrm>
            <a:off x="1847850" y="2816599"/>
            <a:ext cx="19050" cy="21851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/>
          <p:cNvCxnSpPr/>
          <p:nvPr/>
        </p:nvCxnSpPr>
        <p:spPr>
          <a:xfrm flipH="1" flipV="1">
            <a:off x="6017948" y="3174683"/>
            <a:ext cx="90525" cy="14287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/>
          <p:cNvCxnSpPr/>
          <p:nvPr/>
        </p:nvCxnSpPr>
        <p:spPr>
          <a:xfrm>
            <a:off x="5800778" y="2374675"/>
            <a:ext cx="0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/>
          <p:cNvCxnSpPr/>
          <p:nvPr/>
        </p:nvCxnSpPr>
        <p:spPr>
          <a:xfrm flipH="1">
            <a:off x="6525629" y="2228850"/>
            <a:ext cx="23761" cy="36483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/>
          <p:cNvCxnSpPr/>
          <p:nvPr/>
        </p:nvCxnSpPr>
        <p:spPr>
          <a:xfrm flipH="1">
            <a:off x="5863365" y="2468100"/>
            <a:ext cx="67344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/>
          <p:cNvCxnSpPr/>
          <p:nvPr/>
        </p:nvCxnSpPr>
        <p:spPr>
          <a:xfrm flipH="1">
            <a:off x="6061485" y="2975610"/>
            <a:ext cx="76200" cy="418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/>
          <p:cNvCxnSpPr/>
          <p:nvPr/>
        </p:nvCxnSpPr>
        <p:spPr>
          <a:xfrm>
            <a:off x="6185588" y="2797549"/>
            <a:ext cx="19050" cy="21851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Arrow Connector 136"/>
          <p:cNvCxnSpPr/>
          <p:nvPr/>
        </p:nvCxnSpPr>
        <p:spPr>
          <a:xfrm flipH="1" flipV="1">
            <a:off x="3063240" y="3231833"/>
            <a:ext cx="90525" cy="14287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137"/>
          <p:cNvCxnSpPr/>
          <p:nvPr/>
        </p:nvCxnSpPr>
        <p:spPr>
          <a:xfrm>
            <a:off x="2849880" y="2382295"/>
            <a:ext cx="0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/>
          <p:cNvCxnSpPr/>
          <p:nvPr/>
        </p:nvCxnSpPr>
        <p:spPr>
          <a:xfrm flipH="1">
            <a:off x="3609021" y="2217420"/>
            <a:ext cx="23761" cy="36483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Arrow Connector 139"/>
          <p:cNvCxnSpPr/>
          <p:nvPr/>
        </p:nvCxnSpPr>
        <p:spPr>
          <a:xfrm flipH="1">
            <a:off x="2912467" y="2475720"/>
            <a:ext cx="67344" cy="7296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Arrow Connector 140"/>
          <p:cNvCxnSpPr/>
          <p:nvPr/>
        </p:nvCxnSpPr>
        <p:spPr>
          <a:xfrm flipH="1">
            <a:off x="3114397" y="3025140"/>
            <a:ext cx="76200" cy="4186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/>
          <p:cNvCxnSpPr/>
          <p:nvPr/>
        </p:nvCxnSpPr>
        <p:spPr>
          <a:xfrm>
            <a:off x="3234690" y="2831839"/>
            <a:ext cx="19050" cy="21851"/>
          </a:xfrm>
          <a:prstGeom prst="straightConnector1">
            <a:avLst/>
          </a:prstGeom>
          <a:ln w="15875">
            <a:solidFill>
              <a:schemeClr val="bg1"/>
            </a:solidFill>
            <a:headEnd type="none" w="sm" len="sm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61" y="1796602"/>
            <a:ext cx="45720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07" name="Straight Connector 106"/>
          <p:cNvCxnSpPr/>
          <p:nvPr/>
        </p:nvCxnSpPr>
        <p:spPr>
          <a:xfrm>
            <a:off x="1899556" y="5514975"/>
            <a:ext cx="548239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1899556" y="6800039"/>
            <a:ext cx="548239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52416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9</TotalTime>
  <Words>95</Words>
  <Application>Microsoft Office PowerPoint</Application>
  <PresentationFormat>On-screen Show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Pezza, PhD</dc:creator>
  <cp:lastModifiedBy>Roberto Pezza, PhD</cp:lastModifiedBy>
  <cp:revision>41</cp:revision>
  <dcterms:created xsi:type="dcterms:W3CDTF">2011-12-19T16:06:30Z</dcterms:created>
  <dcterms:modified xsi:type="dcterms:W3CDTF">2012-04-18T22:46:06Z</dcterms:modified>
</cp:coreProperties>
</file>